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svg" ContentType="image/svg+xml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26" r:id="rId2"/>
    <p:sldId id="324" r:id="rId3"/>
    <p:sldId id="323" r:id="rId4"/>
    <p:sldId id="315" r:id="rId5"/>
    <p:sldId id="325" r:id="rId6"/>
  </p:sldIdLst>
  <p:sldSz cx="10799763" cy="16256000"/>
  <p:notesSz cx="6858000" cy="9240838"/>
  <p:defaultTextStyle>
    <a:defPPr>
      <a:defRPr lang="en-DE"/>
    </a:defPPr>
    <a:lvl1pPr marL="0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43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287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430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572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717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859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003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146" algn="l" defTabSz="914287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21100"/>
    <a:srgbClr val="FF781A"/>
    <a:srgbClr val="FA2500"/>
    <a:srgbClr val="FFD3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283" autoAdjust="0"/>
    <p:restoredTop sz="93235" autoAdjust="0"/>
  </p:normalViewPr>
  <p:slideViewPr>
    <p:cSldViewPr snapToGrid="0">
      <p:cViewPr varScale="1">
        <p:scale>
          <a:sx n="49" d="100"/>
          <a:sy n="49" d="100"/>
        </p:scale>
        <p:origin x="366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image" Target="../media/image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BFDFFA-25BA-0293-BD8D-E383E7BA50B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349971" y="2660415"/>
            <a:ext cx="8099823" cy="5659496"/>
          </a:xfrm>
        </p:spPr>
        <p:txBody>
          <a:bodyPr anchor="b"/>
          <a:lstStyle>
            <a:lvl1pPr algn="ctr">
              <a:defRPr sz="9448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616403-3C29-6AEA-BBD8-A9860EA9EF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349971" y="8538168"/>
            <a:ext cx="8099823" cy="3924769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44" indent="0" algn="ctr">
              <a:buNone/>
              <a:defRPr sz="3150"/>
            </a:lvl2pPr>
            <a:lvl3pPr marL="1439890" indent="0" algn="ctr">
              <a:buNone/>
              <a:defRPr sz="2835"/>
            </a:lvl3pPr>
            <a:lvl4pPr marL="2159836" indent="0" algn="ctr">
              <a:buNone/>
              <a:defRPr sz="2519"/>
            </a:lvl4pPr>
            <a:lvl5pPr marL="2879781" indent="0" algn="ctr">
              <a:buNone/>
              <a:defRPr sz="2519"/>
            </a:lvl5pPr>
            <a:lvl6pPr marL="3599725" indent="0" algn="ctr">
              <a:buNone/>
              <a:defRPr sz="2519"/>
            </a:lvl6pPr>
            <a:lvl7pPr marL="4319671" indent="0" algn="ctr">
              <a:buNone/>
              <a:defRPr sz="2519"/>
            </a:lvl7pPr>
            <a:lvl8pPr marL="5039616" indent="0" algn="ctr">
              <a:buNone/>
              <a:defRPr sz="2519"/>
            </a:lvl8pPr>
            <a:lvl9pPr marL="5759562" indent="0" algn="ctr">
              <a:buNone/>
              <a:defRPr sz="2519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83BECD-4813-0022-E1B4-889A38D362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02/2026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D106C8-6F4A-0053-DF52-A8EE3CC0F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6BA2B1-4E7B-9704-6494-3BA58EBCCD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505179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75C553-8FA5-C343-AED8-F37351A1EA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0619B89-AE0F-92D6-8DED-1E1C635585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FA227A-4F23-4E2D-9606-A2EB0325B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02/2026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E16280-DE8D-B7C9-7B2E-4A90A5384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87934B-AB96-E93B-EB48-48054DB810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584736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22C80F4-6681-6985-DF11-9BC91C258C7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7728583" y="865482"/>
            <a:ext cx="2328698" cy="1377620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FFAB68-3F76-9130-31FC-5261FFFFC6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742485" y="865482"/>
            <a:ext cx="6851101" cy="1377620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C927C5-5B79-EBA7-43AE-FCE4900B08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02/2026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105E80-4EB1-F5FC-032F-CA708528F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FA3A70-C7F4-5A71-5ED1-046A799724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3202078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203B54-D2AB-04A8-72C0-86D7884496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0FAF1D-69D1-D6A2-177D-C8F3B5FF74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5E1EFF-1175-0BF2-19C8-B774B61522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02/2026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A92FC1-E3D1-CCA2-CE99-0B4C5A780E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D1F1BB-4F0C-4EAC-DD0D-368E568054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716178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C9ED67-42A9-5337-414C-53E6391C81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36860" y="4052715"/>
            <a:ext cx="9314796" cy="6762043"/>
          </a:xfrm>
        </p:spPr>
        <p:txBody>
          <a:bodyPr anchor="b"/>
          <a:lstStyle>
            <a:lvl1pPr>
              <a:defRPr sz="9448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CFFA26-A268-6490-A855-AFB96AAC6E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736860" y="10878732"/>
            <a:ext cx="9314796" cy="3555999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>
                    <a:tint val="75000"/>
                  </a:schemeClr>
                </a:solidFill>
              </a:defRPr>
            </a:lvl1pPr>
            <a:lvl2pPr marL="71994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890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836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4pPr>
            <a:lvl5pPr marL="2879781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5pPr>
            <a:lvl6pPr marL="3599725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6pPr>
            <a:lvl7pPr marL="4319671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7pPr>
            <a:lvl8pPr marL="5039616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8pPr>
            <a:lvl9pPr marL="5759562" indent="0">
              <a:buNone/>
              <a:defRPr sz="251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72B27A1-A20A-F266-017D-094269E0B9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02/2026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93E1EA-7004-3532-5196-DC586A2BF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5B53FB-B915-9652-C019-EE201E9453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83324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874030-BE7A-7CD7-2676-C83197AD5E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8AC6C94-1C4E-AA7F-A1E3-991FF204B0A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742486" y="4327410"/>
            <a:ext cx="4589899" cy="1031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9E5C9D8-41C0-4728-9196-A3434767E9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467381" y="4327410"/>
            <a:ext cx="4589899" cy="103142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06F3778-4172-5586-E0C1-35E2F471A6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02/2026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C256AF-9E72-F0EB-C5B9-D9202C47A5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532DEDD-3065-2605-625D-A2A25F15E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7599198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A7F950-2D11-6605-FA33-61996BB607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3891" y="865484"/>
            <a:ext cx="9314796" cy="314207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4CACC26-4EC6-B85B-61D7-50FCA9C197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743892" y="3984980"/>
            <a:ext cx="4568806" cy="1952976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44" indent="0">
              <a:buNone/>
              <a:defRPr sz="3150" b="1"/>
            </a:lvl2pPr>
            <a:lvl3pPr marL="1439890" indent="0">
              <a:buNone/>
              <a:defRPr sz="2835" b="1"/>
            </a:lvl3pPr>
            <a:lvl4pPr marL="2159836" indent="0">
              <a:buNone/>
              <a:defRPr sz="2519" b="1"/>
            </a:lvl4pPr>
            <a:lvl5pPr marL="2879781" indent="0">
              <a:buNone/>
              <a:defRPr sz="2519" b="1"/>
            </a:lvl5pPr>
            <a:lvl6pPr marL="3599725" indent="0">
              <a:buNone/>
              <a:defRPr sz="2519" b="1"/>
            </a:lvl6pPr>
            <a:lvl7pPr marL="4319671" indent="0">
              <a:buNone/>
              <a:defRPr sz="2519" b="1"/>
            </a:lvl7pPr>
            <a:lvl8pPr marL="5039616" indent="0">
              <a:buNone/>
              <a:defRPr sz="2519" b="1"/>
            </a:lvl8pPr>
            <a:lvl9pPr marL="5759562" indent="0">
              <a:buNone/>
              <a:defRPr sz="251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718B2B-DCAE-097C-BCB8-B312E171F27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743892" y="5937959"/>
            <a:ext cx="4568806" cy="873383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16F2468-380E-A5E1-7CE7-6DF11CFC6B3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5467381" y="3984980"/>
            <a:ext cx="4591306" cy="1952976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44" indent="0">
              <a:buNone/>
              <a:defRPr sz="3150" b="1"/>
            </a:lvl2pPr>
            <a:lvl3pPr marL="1439890" indent="0">
              <a:buNone/>
              <a:defRPr sz="2835" b="1"/>
            </a:lvl3pPr>
            <a:lvl4pPr marL="2159836" indent="0">
              <a:buNone/>
              <a:defRPr sz="2519" b="1"/>
            </a:lvl4pPr>
            <a:lvl5pPr marL="2879781" indent="0">
              <a:buNone/>
              <a:defRPr sz="2519" b="1"/>
            </a:lvl5pPr>
            <a:lvl6pPr marL="3599725" indent="0">
              <a:buNone/>
              <a:defRPr sz="2519" b="1"/>
            </a:lvl6pPr>
            <a:lvl7pPr marL="4319671" indent="0">
              <a:buNone/>
              <a:defRPr sz="2519" b="1"/>
            </a:lvl7pPr>
            <a:lvl8pPr marL="5039616" indent="0">
              <a:buNone/>
              <a:defRPr sz="2519" b="1"/>
            </a:lvl8pPr>
            <a:lvl9pPr marL="5759562" indent="0">
              <a:buNone/>
              <a:defRPr sz="251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3F7E072-B372-7495-DEC4-D8A3188CB2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5467381" y="5937959"/>
            <a:ext cx="4591306" cy="873383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F338556-E0C9-4F13-67E4-47050CBA2A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02/2026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AEA690D-9543-64B9-5000-48949CF87D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F5F2086-B6B1-54CD-3C2E-092069E773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937533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99DD79-EB8A-6ABF-9BCD-1C6EB48435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E2D059B-674D-203E-D42A-7D12CDE755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02/2026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D49DD75-9E0F-CE34-8118-D7CDBA355F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2450052-3781-4A9A-0B78-359AA5A6F0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041463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934C3D7-F8F6-A009-0120-7BB142601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02/2026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816A7D0-60D2-A2DA-3377-B93433D62E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CDFE8E2-656F-1042-0F07-3419BD0338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6207922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35A567-B3A6-2133-332B-43D0D6F204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3894" y="1083734"/>
            <a:ext cx="3483203" cy="3793067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9506E8-5324-AE45-18A7-B8A29BCC8EF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591309" y="2340565"/>
            <a:ext cx="5467381" cy="11552296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C7A6C0-DA4B-B923-9FEF-9B6435AE24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743894" y="4876802"/>
            <a:ext cx="3483203" cy="9034875"/>
          </a:xfrm>
        </p:spPr>
        <p:txBody>
          <a:bodyPr/>
          <a:lstStyle>
            <a:lvl1pPr marL="0" indent="0">
              <a:buNone/>
              <a:defRPr sz="2519"/>
            </a:lvl1pPr>
            <a:lvl2pPr marL="719944" indent="0">
              <a:buNone/>
              <a:defRPr sz="2207"/>
            </a:lvl2pPr>
            <a:lvl3pPr marL="1439890" indent="0">
              <a:buNone/>
              <a:defRPr sz="1889"/>
            </a:lvl3pPr>
            <a:lvl4pPr marL="2159836" indent="0">
              <a:buNone/>
              <a:defRPr sz="1577"/>
            </a:lvl4pPr>
            <a:lvl5pPr marL="2879781" indent="0">
              <a:buNone/>
              <a:defRPr sz="1577"/>
            </a:lvl5pPr>
            <a:lvl6pPr marL="3599725" indent="0">
              <a:buNone/>
              <a:defRPr sz="1577"/>
            </a:lvl6pPr>
            <a:lvl7pPr marL="4319671" indent="0">
              <a:buNone/>
              <a:defRPr sz="1577"/>
            </a:lvl7pPr>
            <a:lvl8pPr marL="5039616" indent="0">
              <a:buNone/>
              <a:defRPr sz="1577"/>
            </a:lvl8pPr>
            <a:lvl9pPr marL="5759562" indent="0">
              <a:buNone/>
              <a:defRPr sz="157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C7EFBA-21E6-8AAE-BCBE-588B1A760A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02/2026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E051DD-24C9-1B04-E740-AF90D0600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323301-FD88-9E2B-96B2-2CB9E320D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343609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E5D11F-7D5D-A4A8-160D-E91E6A6E30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3894" y="1083734"/>
            <a:ext cx="3483203" cy="3793067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6E8D029-50F9-2135-ED13-61F7FB055AB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591309" y="2340565"/>
            <a:ext cx="5467381" cy="11552296"/>
          </a:xfrm>
        </p:spPr>
        <p:txBody>
          <a:bodyPr/>
          <a:lstStyle>
            <a:lvl1pPr marL="0" indent="0">
              <a:buNone/>
              <a:defRPr sz="5039"/>
            </a:lvl1pPr>
            <a:lvl2pPr marL="719944" indent="0">
              <a:buNone/>
              <a:defRPr sz="4409"/>
            </a:lvl2pPr>
            <a:lvl3pPr marL="1439890" indent="0">
              <a:buNone/>
              <a:defRPr sz="3780"/>
            </a:lvl3pPr>
            <a:lvl4pPr marL="2159836" indent="0">
              <a:buNone/>
              <a:defRPr sz="3150"/>
            </a:lvl4pPr>
            <a:lvl5pPr marL="2879781" indent="0">
              <a:buNone/>
              <a:defRPr sz="3150"/>
            </a:lvl5pPr>
            <a:lvl6pPr marL="3599725" indent="0">
              <a:buNone/>
              <a:defRPr sz="3150"/>
            </a:lvl6pPr>
            <a:lvl7pPr marL="4319671" indent="0">
              <a:buNone/>
              <a:defRPr sz="3150"/>
            </a:lvl7pPr>
            <a:lvl8pPr marL="5039616" indent="0">
              <a:buNone/>
              <a:defRPr sz="3150"/>
            </a:lvl8pPr>
            <a:lvl9pPr marL="5759562" indent="0">
              <a:buNone/>
              <a:defRPr sz="315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08DE73-2BC0-DC89-2674-9E1DC3BDA2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743894" y="4876802"/>
            <a:ext cx="3483203" cy="9034875"/>
          </a:xfrm>
        </p:spPr>
        <p:txBody>
          <a:bodyPr/>
          <a:lstStyle>
            <a:lvl1pPr marL="0" indent="0">
              <a:buNone/>
              <a:defRPr sz="2519"/>
            </a:lvl1pPr>
            <a:lvl2pPr marL="719944" indent="0">
              <a:buNone/>
              <a:defRPr sz="2207"/>
            </a:lvl2pPr>
            <a:lvl3pPr marL="1439890" indent="0">
              <a:buNone/>
              <a:defRPr sz="1889"/>
            </a:lvl3pPr>
            <a:lvl4pPr marL="2159836" indent="0">
              <a:buNone/>
              <a:defRPr sz="1577"/>
            </a:lvl4pPr>
            <a:lvl5pPr marL="2879781" indent="0">
              <a:buNone/>
              <a:defRPr sz="1577"/>
            </a:lvl5pPr>
            <a:lvl6pPr marL="3599725" indent="0">
              <a:buNone/>
              <a:defRPr sz="1577"/>
            </a:lvl6pPr>
            <a:lvl7pPr marL="4319671" indent="0">
              <a:buNone/>
              <a:defRPr sz="1577"/>
            </a:lvl7pPr>
            <a:lvl8pPr marL="5039616" indent="0">
              <a:buNone/>
              <a:defRPr sz="1577"/>
            </a:lvl8pPr>
            <a:lvl9pPr marL="5759562" indent="0">
              <a:buNone/>
              <a:defRPr sz="157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C07022D-9932-1790-A1FE-96736180A6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7CCF97-D789-4479-B8DA-E34374C52551}" type="datetimeFigureOut">
              <a:rPr lang="en-DE" smtClean="0"/>
              <a:t>04/02/2026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C13648F-6F22-82EB-ADAF-FEB431E80A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84CF00-DA06-AFB7-EAA8-AA453FFD5F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2605928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5797AF9-8C03-9931-1488-F1583F0A65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742484" y="865484"/>
            <a:ext cx="9314796" cy="31420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97E572-50D4-90BB-167C-AB6F2D99A0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742484" y="4327410"/>
            <a:ext cx="9314796" cy="1031428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056448-CD5C-39F9-D0C7-F5F585F9F2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742484" y="15066910"/>
            <a:ext cx="2429948" cy="865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8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7CCF97-D789-4479-B8DA-E34374C52551}" type="datetimeFigureOut">
              <a:rPr lang="en-DE" smtClean="0"/>
              <a:t>04/02/2026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9CBFBF-B811-6283-66FB-96A60D9E6D2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577422" y="15066910"/>
            <a:ext cx="3644920" cy="865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8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C0BD45-8F0C-4D0E-09DB-A8F703E2CB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7627333" y="15066910"/>
            <a:ext cx="2429948" cy="865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8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50E925-94D2-4B39-9426-B6976BF225AE}" type="slidenum">
              <a:rPr lang="en-DE" smtClean="0"/>
              <a:t>‹Nr.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34176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439890" rtl="0" eaLnBrk="1" latinLnBrk="0" hangingPunct="1">
        <a:lnSpc>
          <a:spcPct val="90000"/>
        </a:lnSpc>
        <a:spcBef>
          <a:spcPct val="0"/>
        </a:spcBef>
        <a:buNone/>
        <a:defRPr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74" indent="-359974" algn="l" defTabSz="1439890" rtl="0" eaLnBrk="1" latinLnBrk="0" hangingPunct="1">
        <a:lnSpc>
          <a:spcPct val="90000"/>
        </a:lnSpc>
        <a:spcBef>
          <a:spcPts val="1577"/>
        </a:spcBef>
        <a:buFont typeface="Arial" panose="020B0604020202020204" pitchFamily="34" charset="0"/>
        <a:buChar char="•"/>
        <a:defRPr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20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863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809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754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700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646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590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536" indent="-359974" algn="l" defTabSz="14398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44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890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836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781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725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671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616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562" algn="l" defTabSz="1439890" rtl="0" eaLnBrk="1" latinLnBrk="0" hangingPunct="1">
        <a:defRPr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7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>
            <a:extLst>
              <a:ext uri="{FF2B5EF4-FFF2-40B4-BE49-F238E27FC236}">
                <a16:creationId xmlns:a16="http://schemas.microsoft.com/office/drawing/2014/main" id="{0DC35475-74F1-8459-2395-6EAD72ECBBCE}"/>
              </a:ext>
            </a:extLst>
          </p:cNvPr>
          <p:cNvSpPr txBox="1"/>
          <p:nvPr/>
        </p:nvSpPr>
        <p:spPr>
          <a:xfrm>
            <a:off x="253169" y="443910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1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 flipH="1">
            <a:off x="4812469" y="7591169"/>
            <a:ext cx="4321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C</a:t>
            </a:r>
            <a:endParaRPr lang="en-US" sz="2000" b="1" dirty="0"/>
          </a:p>
        </p:txBody>
      </p:sp>
      <p:pic>
        <p:nvPicPr>
          <p:cNvPr id="11" name="Graphic 4">
            <a:extLst>
              <a:ext uri="{FF2B5EF4-FFF2-40B4-BE49-F238E27FC236}">
                <a16:creationId xmlns:a16="http://schemas.microsoft.com/office/drawing/2014/main" id="{A15D4604-76C5-1F92-8882-C1B114C0E62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96DAC541-7B7A-43D3-8B79-37D633B846F1}">
                <asvg:svgBlip xmlns="" xmlns:asvg="http://schemas.microsoft.com/office/drawing/2016/SVG/main" r:embed="rId3"/>
              </a:ext>
            </a:extLst>
          </a:blip>
          <a:srcRect l="5617"/>
          <a:stretch/>
        </p:blipFill>
        <p:spPr>
          <a:xfrm>
            <a:off x="944141" y="2818553"/>
            <a:ext cx="9601239" cy="6650741"/>
          </a:xfrm>
          <a:prstGeom prst="rect">
            <a:avLst/>
          </a:prstGeom>
        </p:spPr>
      </p:pic>
      <p:sp>
        <p:nvSpPr>
          <p:cNvPr id="12" name="Rectangle 6">
            <a:extLst>
              <a:ext uri="{FF2B5EF4-FFF2-40B4-BE49-F238E27FC236}">
                <a16:creationId xmlns:a16="http://schemas.microsoft.com/office/drawing/2014/main" id="{C3FF9A08-66B4-8658-ABFF-EDAF3AC2DEC5}"/>
              </a:ext>
            </a:extLst>
          </p:cNvPr>
          <p:cNvSpPr/>
          <p:nvPr/>
        </p:nvSpPr>
        <p:spPr>
          <a:xfrm>
            <a:off x="1115221" y="9694739"/>
            <a:ext cx="182880" cy="18288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Rectangle 7">
            <a:extLst>
              <a:ext uri="{FF2B5EF4-FFF2-40B4-BE49-F238E27FC236}">
                <a16:creationId xmlns:a16="http://schemas.microsoft.com/office/drawing/2014/main" id="{0B76F64C-7D20-1F99-9263-8112557212C6}"/>
              </a:ext>
            </a:extLst>
          </p:cNvPr>
          <p:cNvSpPr/>
          <p:nvPr/>
        </p:nvSpPr>
        <p:spPr>
          <a:xfrm>
            <a:off x="1115221" y="10043989"/>
            <a:ext cx="182880" cy="182880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TextBox 8">
            <a:extLst>
              <a:ext uri="{FF2B5EF4-FFF2-40B4-BE49-F238E27FC236}">
                <a16:creationId xmlns:a16="http://schemas.microsoft.com/office/drawing/2014/main" id="{2C1FF27F-09AE-38DC-CDA1-5FF10D42D9ED}"/>
              </a:ext>
            </a:extLst>
          </p:cNvPr>
          <p:cNvSpPr txBox="1"/>
          <p:nvPr/>
        </p:nvSpPr>
        <p:spPr>
          <a:xfrm>
            <a:off x="1242221" y="9635664"/>
            <a:ext cx="16706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Number of total CTC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9">
            <a:extLst>
              <a:ext uri="{FF2B5EF4-FFF2-40B4-BE49-F238E27FC236}">
                <a16:creationId xmlns:a16="http://schemas.microsoft.com/office/drawing/2014/main" id="{22EE8E27-2A8D-CE49-75D1-3D05470386FB}"/>
              </a:ext>
            </a:extLst>
          </p:cNvPr>
          <p:cNvSpPr txBox="1"/>
          <p:nvPr/>
        </p:nvSpPr>
        <p:spPr>
          <a:xfrm>
            <a:off x="1242221" y="9984914"/>
            <a:ext cx="20024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DE" sz="1200" dirty="0">
                <a:latin typeface="Arial" panose="020B0604020202020204" pitchFamily="34" charset="0"/>
                <a:cs typeface="Arial" panose="020B0604020202020204" pitchFamily="34" charset="0"/>
              </a:rPr>
              <a:t>Number of apoptotic CTCs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feld 1"/>
          <p:cNvSpPr txBox="1"/>
          <p:nvPr/>
        </p:nvSpPr>
        <p:spPr>
          <a:xfrm rot="16200000">
            <a:off x="-1233249" y="5854755"/>
            <a:ext cx="318721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Number of  (apoptotic) CTCs</a:t>
            </a:r>
            <a:endParaRPr lang="en-US" sz="2000" b="1" dirty="0"/>
          </a:p>
        </p:txBody>
      </p:sp>
      <p:sp>
        <p:nvSpPr>
          <p:cNvPr id="3" name="Textfeld 2"/>
          <p:cNvSpPr txBox="1"/>
          <p:nvPr/>
        </p:nvSpPr>
        <p:spPr>
          <a:xfrm>
            <a:off x="510344" y="3989071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510344" y="5480316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0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510344" y="7039401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0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50421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2" name="Picture 2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7"/>
          <a:stretch/>
        </p:blipFill>
        <p:spPr bwMode="auto">
          <a:xfrm>
            <a:off x="5577412" y="4371872"/>
            <a:ext cx="5013307" cy="13113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8" name="Grafik 57">
            <a:extLst>
              <a:ext uri="{FF2B5EF4-FFF2-40B4-BE49-F238E27FC236}">
                <a16:creationId xmlns:a16="http://schemas.microsoft.com/office/drawing/2014/main" id="{A2374371-AB74-4892-83CD-94BCA3167649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577412" y="1406248"/>
            <a:ext cx="5149391" cy="2618472"/>
          </a:xfrm>
          <a:prstGeom prst="rect">
            <a:avLst/>
          </a:prstGeom>
        </p:spPr>
      </p:pic>
      <p:sp>
        <p:nvSpPr>
          <p:cNvPr id="61" name="Textfeld 60"/>
          <p:cNvSpPr txBox="1"/>
          <p:nvPr/>
        </p:nvSpPr>
        <p:spPr>
          <a:xfrm rot="16200000">
            <a:off x="4664597" y="2089429"/>
            <a:ext cx="1274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pre-RT</a:t>
            </a:r>
          </a:p>
        </p:txBody>
      </p:sp>
      <p:sp>
        <p:nvSpPr>
          <p:cNvPr id="4" name="Textfeld 3">
            <a:extLst>
              <a:ext uri="{FF2B5EF4-FFF2-40B4-BE49-F238E27FC236}">
                <a16:creationId xmlns:a16="http://schemas.microsoft.com/office/drawing/2014/main" id="{0DC35475-74F1-8459-2395-6EAD72ECBBCE}"/>
              </a:ext>
            </a:extLst>
          </p:cNvPr>
          <p:cNvSpPr txBox="1"/>
          <p:nvPr/>
        </p:nvSpPr>
        <p:spPr>
          <a:xfrm>
            <a:off x="164563" y="392714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2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Pfeil nach rechts 24"/>
          <p:cNvSpPr/>
          <p:nvPr/>
        </p:nvSpPr>
        <p:spPr>
          <a:xfrm rot="19040104">
            <a:off x="2855950" y="681443"/>
            <a:ext cx="443532" cy="152400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51" name="Tabelle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66245512"/>
              </p:ext>
            </p:extLst>
          </p:nvPr>
        </p:nvGraphicFramePr>
        <p:xfrm>
          <a:off x="501035" y="4524437"/>
          <a:ext cx="4460222" cy="11887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438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41633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indent="0" algn="l">
                        <a:buNone/>
                      </a:pPr>
                      <a:r>
                        <a:rPr lang="de-DE" sz="1800" b="0" dirty="0" err="1">
                          <a:solidFill>
                            <a:schemeClr val="tx1"/>
                          </a:solidFill>
                          <a:latin typeface="+mn-lt"/>
                        </a:rPr>
                        <a:t>pre</a:t>
                      </a:r>
                      <a:r>
                        <a:rPr lang="de-DE" sz="1800" b="0" dirty="0">
                          <a:solidFill>
                            <a:schemeClr val="tx1"/>
                          </a:solidFill>
                          <a:latin typeface="+mn-lt"/>
                        </a:rPr>
                        <a:t>- RT</a:t>
                      </a:r>
                    </a:p>
                  </a:txBody>
                  <a:tcPr marL="121920" marR="121920" marT="60960" marB="6096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1800" b="0" dirty="0">
                          <a:solidFill>
                            <a:schemeClr val="tx1"/>
                          </a:solidFill>
                          <a:latin typeface="+mn-lt"/>
                        </a:rPr>
                        <a:t>56 CTCs (39 % </a:t>
                      </a:r>
                      <a:r>
                        <a:rPr lang="de-DE" sz="1800" b="0" dirty="0" err="1">
                          <a:solidFill>
                            <a:schemeClr val="tx1"/>
                          </a:solidFill>
                          <a:latin typeface="+mn-lt"/>
                        </a:rPr>
                        <a:t>apoptotic</a:t>
                      </a:r>
                      <a:r>
                        <a:rPr lang="de-DE" sz="1800" b="0" dirty="0">
                          <a:solidFill>
                            <a:schemeClr val="tx1"/>
                          </a:solidFill>
                          <a:latin typeface="+mn-lt"/>
                        </a:rPr>
                        <a:t> )</a:t>
                      </a:r>
                    </a:p>
                  </a:txBody>
                  <a:tcPr marL="121920" marR="121920" marT="60960" marB="6096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65893">
                <a:tc>
                  <a:txBody>
                    <a:bodyPr/>
                    <a:lstStyle/>
                    <a:p>
                      <a:pPr algn="l"/>
                      <a:r>
                        <a:rPr lang="de-DE" sz="1800" b="0" dirty="0">
                          <a:solidFill>
                            <a:schemeClr val="tx1"/>
                          </a:solidFill>
                          <a:latin typeface="+mn-lt"/>
                        </a:rPr>
                        <a:t>post-RT</a:t>
                      </a:r>
                    </a:p>
                  </a:txBody>
                  <a:tcPr marL="121920" marR="121920" marT="60960" marB="6096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b="0" dirty="0">
                          <a:solidFill>
                            <a:schemeClr val="tx1"/>
                          </a:solidFill>
                          <a:latin typeface="+mn-lt"/>
                        </a:rPr>
                        <a:t>70 CTCs (80 %  </a:t>
                      </a:r>
                      <a:r>
                        <a:rPr lang="de-DE" sz="1800" b="0" dirty="0" err="1">
                          <a:solidFill>
                            <a:schemeClr val="tx1"/>
                          </a:solidFill>
                          <a:latin typeface="+mn-lt"/>
                        </a:rPr>
                        <a:t>apoptotic</a:t>
                      </a:r>
                      <a:r>
                        <a:rPr lang="de-DE" sz="1800" b="0" dirty="0">
                          <a:solidFill>
                            <a:schemeClr val="tx1"/>
                          </a:solidFill>
                          <a:latin typeface="+mn-lt"/>
                        </a:rPr>
                        <a:t>)</a:t>
                      </a:r>
                    </a:p>
                  </a:txBody>
                  <a:tcPr marL="121920" marR="121920" marT="60960" marB="6096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12420">
                <a:tc>
                  <a:txBody>
                    <a:bodyPr/>
                    <a:lstStyle/>
                    <a:p>
                      <a:pPr algn="l"/>
                      <a:r>
                        <a:rPr lang="de-DE" sz="1800" b="0" dirty="0">
                          <a:solidFill>
                            <a:schemeClr val="tx1"/>
                          </a:solidFill>
                          <a:latin typeface="+mn-lt"/>
                        </a:rPr>
                        <a:t>MRI</a:t>
                      </a:r>
                    </a:p>
                  </a:txBody>
                  <a:tcPr marL="121920" marR="121920" marT="60960" marB="60960"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800" b="0" dirty="0">
                          <a:solidFill>
                            <a:schemeClr val="tx1"/>
                          </a:solidFill>
                          <a:latin typeface="+mn-lt"/>
                        </a:rPr>
                        <a:t>0 CTCs</a:t>
                      </a:r>
                    </a:p>
                  </a:txBody>
                  <a:tcPr marL="121920" marR="121920" marT="60960" marB="60960">
                    <a:solidFill>
                      <a:schemeClr val="bg1">
                        <a:lumMod val="8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53" name="TextBox 19"/>
          <p:cNvSpPr txBox="1"/>
          <p:nvPr/>
        </p:nvSpPr>
        <p:spPr>
          <a:xfrm>
            <a:off x="6571991" y="1087015"/>
            <a:ext cx="880754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</a:rPr>
              <a:t>keratin</a:t>
            </a:r>
          </a:p>
        </p:txBody>
      </p:sp>
      <p:sp>
        <p:nvSpPr>
          <p:cNvPr id="54" name="TextBox 20"/>
          <p:cNvSpPr txBox="1"/>
          <p:nvPr/>
        </p:nvSpPr>
        <p:spPr>
          <a:xfrm>
            <a:off x="7820130" y="1087015"/>
            <a:ext cx="666336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</a:rPr>
              <a:t>DAPI</a:t>
            </a:r>
          </a:p>
        </p:txBody>
      </p:sp>
      <p:sp>
        <p:nvSpPr>
          <p:cNvPr id="55" name="TextBox 21"/>
          <p:cNvSpPr txBox="1"/>
          <p:nvPr/>
        </p:nvSpPr>
        <p:spPr>
          <a:xfrm>
            <a:off x="8876600" y="1087015"/>
            <a:ext cx="705642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</a:rPr>
              <a:t>CD45</a:t>
            </a:r>
          </a:p>
        </p:txBody>
      </p:sp>
      <p:sp>
        <p:nvSpPr>
          <p:cNvPr id="56" name="TextBox 22"/>
          <p:cNvSpPr txBox="1"/>
          <p:nvPr/>
        </p:nvSpPr>
        <p:spPr>
          <a:xfrm>
            <a:off x="9922865" y="1085029"/>
            <a:ext cx="638316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</a:rPr>
              <a:t>M30</a:t>
            </a:r>
          </a:p>
        </p:txBody>
      </p:sp>
      <p:sp>
        <p:nvSpPr>
          <p:cNvPr id="60" name="TextBox 19"/>
          <p:cNvSpPr txBox="1"/>
          <p:nvPr/>
        </p:nvSpPr>
        <p:spPr>
          <a:xfrm>
            <a:off x="5491795" y="1087713"/>
            <a:ext cx="814069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rgbClr val="002060"/>
                </a:solidFill>
              </a:rPr>
              <a:t>merge</a:t>
            </a:r>
          </a:p>
        </p:txBody>
      </p:sp>
      <p:sp>
        <p:nvSpPr>
          <p:cNvPr id="74" name="Textfeld 13">
            <a:extLst>
              <a:ext uri="{FF2B5EF4-FFF2-40B4-BE49-F238E27FC236}">
                <a16:creationId xmlns:a16="http://schemas.microsoft.com/office/drawing/2014/main" id="{3647ED1D-0B51-986B-107C-95CFCFD872DB}"/>
              </a:ext>
            </a:extLst>
          </p:cNvPr>
          <p:cNvSpPr txBox="1"/>
          <p:nvPr/>
        </p:nvSpPr>
        <p:spPr>
          <a:xfrm>
            <a:off x="926743" y="3712321"/>
            <a:ext cx="1374800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133" dirty="0" err="1"/>
              <a:t>Before</a:t>
            </a:r>
            <a:r>
              <a:rPr lang="de-DE" sz="2133" dirty="0"/>
              <a:t> </a:t>
            </a:r>
            <a:r>
              <a:rPr lang="de-DE" sz="2133" dirty="0" smtClean="0"/>
              <a:t>SRS</a:t>
            </a:r>
            <a:endParaRPr lang="de-DE" sz="2133" dirty="0"/>
          </a:p>
        </p:txBody>
      </p:sp>
      <p:sp>
        <p:nvSpPr>
          <p:cNvPr id="75" name="Textfeld 14">
            <a:extLst>
              <a:ext uri="{FF2B5EF4-FFF2-40B4-BE49-F238E27FC236}">
                <a16:creationId xmlns:a16="http://schemas.microsoft.com/office/drawing/2014/main" id="{EE16AC35-F923-EDF4-BD23-47DE6AB09956}"/>
              </a:ext>
            </a:extLst>
          </p:cNvPr>
          <p:cNvSpPr txBox="1"/>
          <p:nvPr/>
        </p:nvSpPr>
        <p:spPr>
          <a:xfrm>
            <a:off x="2904805" y="3724170"/>
            <a:ext cx="2133661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133" dirty="0"/>
              <a:t>6 </a:t>
            </a:r>
            <a:r>
              <a:rPr lang="de-DE" sz="2133" dirty="0" err="1"/>
              <a:t>weeks</a:t>
            </a:r>
            <a:r>
              <a:rPr lang="de-DE" sz="2133" dirty="0"/>
              <a:t> after </a:t>
            </a:r>
            <a:r>
              <a:rPr lang="de-DE" sz="2133" dirty="0" smtClean="0"/>
              <a:t>SRS</a:t>
            </a:r>
            <a:endParaRPr lang="de-DE" sz="2133" dirty="0"/>
          </a:p>
        </p:txBody>
      </p:sp>
      <p:grpSp>
        <p:nvGrpSpPr>
          <p:cNvPr id="76" name="Group 17">
            <a:extLst>
              <a:ext uri="{FF2B5EF4-FFF2-40B4-BE49-F238E27FC236}">
                <a16:creationId xmlns:a16="http://schemas.microsoft.com/office/drawing/2014/main" id="{7B7A6543-B488-C250-7E0E-47E645886173}"/>
              </a:ext>
            </a:extLst>
          </p:cNvPr>
          <p:cNvGrpSpPr>
            <a:grpSpLocks/>
          </p:cNvGrpSpPr>
          <p:nvPr/>
        </p:nvGrpSpPr>
        <p:grpSpPr>
          <a:xfrm>
            <a:off x="363347" y="1289583"/>
            <a:ext cx="2276666" cy="2367126"/>
            <a:chOff x="368680" y="14084"/>
            <a:chExt cx="5057961" cy="5026770"/>
          </a:xfrm>
        </p:grpSpPr>
        <p:pic>
          <p:nvPicPr>
            <p:cNvPr id="77" name="Picture 11">
              <a:extLst>
                <a:ext uri="{FF2B5EF4-FFF2-40B4-BE49-F238E27FC236}">
                  <a16:creationId xmlns:a16="http://schemas.microsoft.com/office/drawing/2014/main" id="{2241A320-6034-A0EC-2B3B-7FEEF28F0F4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58" t="14802" r="47007" b="-595"/>
            <a:stretch/>
          </p:blipFill>
          <p:spPr>
            <a:xfrm>
              <a:off x="368680" y="14084"/>
              <a:ext cx="5057961" cy="5026770"/>
            </a:xfrm>
            <a:prstGeom prst="rect">
              <a:avLst/>
            </a:prstGeom>
          </p:spPr>
        </p:pic>
        <p:sp>
          <p:nvSpPr>
            <p:cNvPr id="78" name="Oval 14">
              <a:extLst>
                <a:ext uri="{FF2B5EF4-FFF2-40B4-BE49-F238E27FC236}">
                  <a16:creationId xmlns:a16="http://schemas.microsoft.com/office/drawing/2014/main" id="{38BE77E0-103B-04A0-CED1-1C1267699C0E}"/>
                </a:ext>
              </a:extLst>
            </p:cNvPr>
            <p:cNvSpPr/>
            <p:nvPr/>
          </p:nvSpPr>
          <p:spPr>
            <a:xfrm>
              <a:off x="1762560" y="3326194"/>
              <a:ext cx="433540" cy="427328"/>
            </a:xfrm>
            <a:prstGeom prst="ellipse">
              <a:avLst/>
            </a:prstGeom>
            <a:noFill/>
            <a:ln>
              <a:solidFill>
                <a:srgbClr val="FA25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79" name="Group 16">
            <a:extLst>
              <a:ext uri="{FF2B5EF4-FFF2-40B4-BE49-F238E27FC236}">
                <a16:creationId xmlns:a16="http://schemas.microsoft.com/office/drawing/2014/main" id="{60E893C7-AA28-C0B1-137E-F621A96367F1}"/>
              </a:ext>
            </a:extLst>
          </p:cNvPr>
          <p:cNvGrpSpPr>
            <a:grpSpLocks/>
          </p:cNvGrpSpPr>
          <p:nvPr/>
        </p:nvGrpSpPr>
        <p:grpSpPr>
          <a:xfrm>
            <a:off x="2904805" y="1289583"/>
            <a:ext cx="2276666" cy="2347689"/>
            <a:chOff x="-4987376" y="73253"/>
            <a:chExt cx="5034510" cy="5026770"/>
          </a:xfrm>
        </p:grpSpPr>
        <p:pic>
          <p:nvPicPr>
            <p:cNvPr id="80" name="Picture 7">
              <a:extLst>
                <a:ext uri="{FF2B5EF4-FFF2-40B4-BE49-F238E27FC236}">
                  <a16:creationId xmlns:a16="http://schemas.microsoft.com/office/drawing/2014/main" id="{86CBF9C2-74D1-F199-1AD4-AEEC81A9405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70" t="13812" r="47513"/>
            <a:stretch/>
          </p:blipFill>
          <p:spPr>
            <a:xfrm>
              <a:off x="-4987376" y="73253"/>
              <a:ext cx="5034510" cy="5026770"/>
            </a:xfrm>
            <a:prstGeom prst="rect">
              <a:avLst/>
            </a:prstGeom>
          </p:spPr>
        </p:pic>
        <p:sp>
          <p:nvSpPr>
            <p:cNvPr id="81" name="Oval 15">
              <a:extLst>
                <a:ext uri="{FF2B5EF4-FFF2-40B4-BE49-F238E27FC236}">
                  <a16:creationId xmlns:a16="http://schemas.microsoft.com/office/drawing/2014/main" id="{06491893-413A-4520-D177-35EFA6E1109C}"/>
                </a:ext>
              </a:extLst>
            </p:cNvPr>
            <p:cNvSpPr/>
            <p:nvPr/>
          </p:nvSpPr>
          <p:spPr>
            <a:xfrm>
              <a:off x="-3641775" y="3326194"/>
              <a:ext cx="431529" cy="430866"/>
            </a:xfrm>
            <a:prstGeom prst="ellipse">
              <a:avLst/>
            </a:prstGeom>
            <a:noFill/>
            <a:ln>
              <a:solidFill>
                <a:srgbClr val="FA25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cxnSp>
        <p:nvCxnSpPr>
          <p:cNvPr id="59" name="Gerader Verbinder 58"/>
          <p:cNvCxnSpPr>
            <a:cxnSpLocks/>
          </p:cNvCxnSpPr>
          <p:nvPr/>
        </p:nvCxnSpPr>
        <p:spPr>
          <a:xfrm flipH="1" flipV="1">
            <a:off x="5491795" y="1406248"/>
            <a:ext cx="12658" cy="2618472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Gerader Verbinder 82"/>
          <p:cNvCxnSpPr/>
          <p:nvPr/>
        </p:nvCxnSpPr>
        <p:spPr>
          <a:xfrm flipH="1">
            <a:off x="5571233" y="4251303"/>
            <a:ext cx="6179" cy="1216033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feld 83"/>
          <p:cNvSpPr txBox="1"/>
          <p:nvPr/>
        </p:nvSpPr>
        <p:spPr>
          <a:xfrm rot="16200000">
            <a:off x="4846272" y="4652924"/>
            <a:ext cx="1054680" cy="3612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00" b="1" dirty="0">
                <a:latin typeface="Arial" panose="020B0604020202020204" pitchFamily="34" charset="0"/>
                <a:cs typeface="Arial" panose="020B0604020202020204" pitchFamily="34" charset="0"/>
              </a:rPr>
              <a:t>post-RT</a:t>
            </a:r>
          </a:p>
        </p:txBody>
      </p:sp>
    </p:spTree>
    <p:extLst>
      <p:ext uri="{BB962C8B-B14F-4D97-AF65-F5344CB8AC3E}">
        <p14:creationId xmlns:p14="http://schemas.microsoft.com/office/powerpoint/2010/main" val="344753515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Obj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0106875"/>
              </p:ext>
            </p:extLst>
          </p:nvPr>
        </p:nvGraphicFramePr>
        <p:xfrm>
          <a:off x="1172354" y="1869567"/>
          <a:ext cx="4572905" cy="4760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6" name="Prism 8" r:id="rId3" imgW="7414114" imgH="7717741" progId="Prism8.Document">
                  <p:embed/>
                </p:oleObj>
              </mc:Choice>
              <mc:Fallback>
                <p:oleObj name="Prism 8" r:id="rId3" imgW="7414114" imgH="771774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72354" y="1869567"/>
                        <a:ext cx="4572905" cy="4760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feld 6">
            <a:extLst>
              <a:ext uri="{FF2B5EF4-FFF2-40B4-BE49-F238E27FC236}">
                <a16:creationId xmlns:a16="http://schemas.microsoft.com/office/drawing/2014/main" id="{0DC35475-74F1-8459-2395-6EAD72ECBBCE}"/>
              </a:ext>
            </a:extLst>
          </p:cNvPr>
          <p:cNvSpPr txBox="1"/>
          <p:nvPr/>
        </p:nvSpPr>
        <p:spPr>
          <a:xfrm>
            <a:off x="337728" y="278129"/>
            <a:ext cx="26597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3</a:t>
            </a:r>
            <a:endParaRPr lang="de-D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feld 4"/>
          <p:cNvSpPr txBox="1"/>
          <p:nvPr/>
        </p:nvSpPr>
        <p:spPr>
          <a:xfrm>
            <a:off x="490128" y="1624605"/>
            <a:ext cx="34015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/>
              <a:t>A</a:t>
            </a:r>
            <a:endParaRPr lang="en-US" sz="2000" b="1" dirty="0"/>
          </a:p>
        </p:txBody>
      </p:sp>
      <p:sp>
        <p:nvSpPr>
          <p:cNvPr id="6" name="Textfeld 5"/>
          <p:cNvSpPr txBox="1"/>
          <p:nvPr/>
        </p:nvSpPr>
        <p:spPr>
          <a:xfrm flipH="1">
            <a:off x="5049428" y="1641315"/>
            <a:ext cx="43211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/>
              <a:t>B</a:t>
            </a:r>
            <a:endParaRPr lang="en-US" sz="2000" b="1" dirty="0"/>
          </a:p>
        </p:txBody>
      </p:sp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72783717"/>
              </p:ext>
            </p:extLst>
          </p:nvPr>
        </p:nvGraphicFramePr>
        <p:xfrm>
          <a:off x="5339535" y="2114609"/>
          <a:ext cx="4133223" cy="4441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7" name="Prism 8" r:id="rId5" imgW="7674852" imgH="8248248" progId="Prism8.Document">
                  <p:embed/>
                </p:oleObj>
              </mc:Choice>
              <mc:Fallback>
                <p:oleObj name="Prism 8" r:id="rId5" imgW="7674852" imgH="824824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5339535" y="2114609"/>
                        <a:ext cx="4133223" cy="4441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8871960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uppieren 4"/>
          <p:cNvGrpSpPr/>
          <p:nvPr/>
        </p:nvGrpSpPr>
        <p:grpSpPr>
          <a:xfrm>
            <a:off x="131021" y="213003"/>
            <a:ext cx="11082595" cy="12177486"/>
            <a:chOff x="131021" y="213003"/>
            <a:chExt cx="11082595" cy="12177486"/>
          </a:xfrm>
          <a:noFill/>
        </p:grpSpPr>
        <p:pic>
          <p:nvPicPr>
            <p:cNvPr id="39" name="Grafik 3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81060" y="4613830"/>
              <a:ext cx="6101708" cy="3960000"/>
            </a:xfrm>
            <a:prstGeom prst="rect">
              <a:avLst/>
            </a:prstGeom>
            <a:grpFill/>
          </p:spPr>
        </p:pic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3"/>
            <a:srcRect r="12731" b="10735"/>
            <a:stretch/>
          </p:blipFill>
          <p:spPr>
            <a:xfrm>
              <a:off x="5439623" y="948254"/>
              <a:ext cx="5324927" cy="3534845"/>
            </a:xfrm>
            <a:prstGeom prst="rect">
              <a:avLst/>
            </a:prstGeom>
            <a:grpFill/>
          </p:spPr>
        </p:pic>
        <p:pic>
          <p:nvPicPr>
            <p:cNvPr id="3" name="Grafik 2"/>
            <p:cNvPicPr>
              <a:picLocks noChangeAspect="1"/>
            </p:cNvPicPr>
            <p:nvPr/>
          </p:nvPicPr>
          <p:blipFill rotWithShape="1">
            <a:blip r:embed="rId4"/>
            <a:srcRect r="10979" b="10188"/>
            <a:stretch/>
          </p:blipFill>
          <p:spPr>
            <a:xfrm>
              <a:off x="131021" y="846655"/>
              <a:ext cx="5428343" cy="3556552"/>
            </a:xfrm>
            <a:prstGeom prst="rect">
              <a:avLst/>
            </a:prstGeom>
            <a:grpFill/>
          </p:spPr>
        </p:pic>
        <p:sp>
          <p:nvSpPr>
            <p:cNvPr id="4" name="Textfeld 3"/>
            <p:cNvSpPr txBox="1"/>
            <p:nvPr/>
          </p:nvSpPr>
          <p:spPr>
            <a:xfrm>
              <a:off x="308317" y="213003"/>
              <a:ext cx="2749471" cy="369332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4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2845192" y="1360559"/>
              <a:ext cx="1452385" cy="338554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≥ 2 CTC  P= </a:t>
              </a:r>
              <a:r>
                <a:rPr lang="en-US" sz="1600" b="1" dirty="0" err="1" smtClean="0"/>
                <a:t>n.s</a:t>
              </a:r>
              <a:r>
                <a:rPr lang="en-US" sz="1600" b="1" dirty="0" smtClean="0"/>
                <a:t>.</a:t>
              </a:r>
              <a:endParaRPr lang="en-US" sz="1600" b="1" dirty="0"/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7814854" y="1360559"/>
              <a:ext cx="1452385" cy="338554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≥ 5 CTC  P= </a:t>
              </a:r>
              <a:r>
                <a:rPr lang="en-US" sz="1600" b="1" dirty="0" err="1" smtClean="0"/>
                <a:t>n.s</a:t>
              </a:r>
              <a:r>
                <a:rPr lang="en-US" sz="1600" b="1" dirty="0" smtClean="0"/>
                <a:t>.</a:t>
              </a:r>
              <a:endParaRPr lang="en-US" sz="1600" b="1" dirty="0"/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2915946" y="5066628"/>
              <a:ext cx="1622304" cy="338554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≥ 5 CTC  P= 0.012</a:t>
              </a:r>
              <a:endParaRPr lang="en-US" sz="1600" b="1" dirty="0"/>
            </a:p>
          </p:txBody>
        </p:sp>
        <p:pic>
          <p:nvPicPr>
            <p:cNvPr id="23" name="Grafik 22"/>
            <p:cNvPicPr>
              <a:picLocks noChangeAspect="1"/>
            </p:cNvPicPr>
            <p:nvPr/>
          </p:nvPicPr>
          <p:blipFill rotWithShape="1">
            <a:blip r:embed="rId5"/>
            <a:srcRect r="11915" b="10322"/>
            <a:stretch/>
          </p:blipFill>
          <p:spPr>
            <a:xfrm>
              <a:off x="5283195" y="8839251"/>
              <a:ext cx="5374690" cy="3551238"/>
            </a:xfrm>
            <a:prstGeom prst="rect">
              <a:avLst/>
            </a:prstGeom>
            <a:grpFill/>
          </p:spPr>
        </p:pic>
        <p:pic>
          <p:nvPicPr>
            <p:cNvPr id="24" name="Grafik 23"/>
            <p:cNvPicPr>
              <a:picLocks noChangeAspect="1"/>
            </p:cNvPicPr>
            <p:nvPr/>
          </p:nvPicPr>
          <p:blipFill rotWithShape="1">
            <a:blip r:embed="rId6"/>
            <a:srcRect r="12725" b="10202"/>
            <a:stretch/>
          </p:blipFill>
          <p:spPr>
            <a:xfrm>
              <a:off x="308317" y="8792296"/>
              <a:ext cx="5321876" cy="3556000"/>
            </a:xfrm>
            <a:prstGeom prst="rect">
              <a:avLst/>
            </a:prstGeom>
            <a:grpFill/>
          </p:spPr>
        </p:pic>
        <p:pic>
          <p:nvPicPr>
            <p:cNvPr id="25" name="Grafik 24"/>
            <p:cNvPicPr>
              <a:picLocks noChangeAspect="1"/>
            </p:cNvPicPr>
            <p:nvPr/>
          </p:nvPicPr>
          <p:blipFill rotWithShape="1">
            <a:blip r:embed="rId7"/>
            <a:srcRect r="10904" b="9881"/>
            <a:stretch/>
          </p:blipFill>
          <p:spPr>
            <a:xfrm>
              <a:off x="5283195" y="4711393"/>
              <a:ext cx="5436394" cy="3568700"/>
            </a:xfrm>
            <a:prstGeom prst="rect">
              <a:avLst/>
            </a:prstGeom>
            <a:grpFill/>
          </p:spPr>
        </p:pic>
        <p:sp>
          <p:nvSpPr>
            <p:cNvPr id="26" name="Textfeld 25"/>
            <p:cNvSpPr txBox="1"/>
            <p:nvPr/>
          </p:nvSpPr>
          <p:spPr>
            <a:xfrm>
              <a:off x="2845192" y="9311037"/>
              <a:ext cx="1622304" cy="338554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≥ 5 CTC  P&gt; 0.001</a:t>
              </a:r>
              <a:endParaRPr lang="en-US" sz="1600" b="1" dirty="0"/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7749131" y="5657234"/>
              <a:ext cx="1518108" cy="338554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≥ 5 CTC  P= 0.71</a:t>
              </a:r>
              <a:endParaRPr lang="en-US" sz="1600" b="1" dirty="0"/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7986698" y="9330233"/>
              <a:ext cx="1622304" cy="338554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/>
                <a:t>≥ 5 CTC  P= 0.048</a:t>
              </a:r>
              <a:endParaRPr lang="en-US" sz="1600" b="1" dirty="0"/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302432" y="4302980"/>
              <a:ext cx="306494" cy="369332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C</a:t>
              </a:r>
              <a:endParaRPr lang="en-US" b="1" dirty="0"/>
            </a:p>
          </p:txBody>
        </p:sp>
        <p:sp>
          <p:nvSpPr>
            <p:cNvPr id="31" name="Textfeld 30"/>
            <p:cNvSpPr txBox="1"/>
            <p:nvPr/>
          </p:nvSpPr>
          <p:spPr>
            <a:xfrm flipH="1">
              <a:off x="5809873" y="4562912"/>
              <a:ext cx="432119" cy="381000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D</a:t>
              </a:r>
              <a:endParaRPr lang="en-US" b="1" dirty="0"/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297853" y="647700"/>
              <a:ext cx="324128" cy="369332"/>
            </a:xfrm>
            <a:prstGeom prst="rect">
              <a:avLst/>
            </a:prstGeom>
            <a:grp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A</a:t>
              </a:r>
              <a:endParaRPr lang="en-US" b="1" dirty="0"/>
            </a:p>
          </p:txBody>
        </p:sp>
        <p:sp>
          <p:nvSpPr>
            <p:cNvPr id="33" name="Textfeld 32"/>
            <p:cNvSpPr txBox="1"/>
            <p:nvPr/>
          </p:nvSpPr>
          <p:spPr>
            <a:xfrm flipH="1">
              <a:off x="5436026" y="636032"/>
              <a:ext cx="432119" cy="381000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B</a:t>
              </a:r>
              <a:endParaRPr lang="en-US" b="1" dirty="0"/>
            </a:p>
          </p:txBody>
        </p:sp>
        <p:sp>
          <p:nvSpPr>
            <p:cNvPr id="35" name="Textfeld 34"/>
            <p:cNvSpPr txBox="1"/>
            <p:nvPr/>
          </p:nvSpPr>
          <p:spPr>
            <a:xfrm flipH="1">
              <a:off x="308317" y="8554862"/>
              <a:ext cx="5774257" cy="369332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b="1" dirty="0" smtClean="0"/>
                <a:t>E</a:t>
              </a:r>
              <a:endParaRPr lang="en-US" b="1" dirty="0"/>
            </a:p>
          </p:txBody>
        </p:sp>
        <p:sp>
          <p:nvSpPr>
            <p:cNvPr id="36" name="Textfeld 35"/>
            <p:cNvSpPr txBox="1"/>
            <p:nvPr/>
          </p:nvSpPr>
          <p:spPr>
            <a:xfrm flipH="1">
              <a:off x="5439359" y="8573830"/>
              <a:ext cx="5774257" cy="369332"/>
            </a:xfrm>
            <a:prstGeom prst="rect">
              <a:avLst/>
            </a:prstGeom>
            <a:grpFill/>
          </p:spPr>
          <p:txBody>
            <a:bodyPr wrap="square" rtlCol="0">
              <a:spAutoFit/>
            </a:bodyPr>
            <a:lstStyle/>
            <a:p>
              <a:r>
                <a:rPr lang="en-US" b="1" dirty="0"/>
                <a:t>F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5088008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/>
          <a:srcRect r="25199" b="45"/>
          <a:stretch/>
        </p:blipFill>
        <p:spPr>
          <a:xfrm>
            <a:off x="5243483" y="7168234"/>
            <a:ext cx="5556280" cy="4374686"/>
          </a:xfrm>
          <a:prstGeom prst="rect">
            <a:avLst/>
          </a:prstGeom>
        </p:spPr>
      </p:pic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3"/>
          <a:srcRect r="25868"/>
          <a:stretch/>
        </p:blipFill>
        <p:spPr>
          <a:xfrm>
            <a:off x="156696" y="7168234"/>
            <a:ext cx="5506607" cy="4376664"/>
          </a:xfrm>
          <a:prstGeom prst="rect">
            <a:avLst/>
          </a:prstGeom>
        </p:spPr>
      </p:pic>
      <p:sp>
        <p:nvSpPr>
          <p:cNvPr id="4" name="Textfeld 3"/>
          <p:cNvSpPr txBox="1"/>
          <p:nvPr/>
        </p:nvSpPr>
        <p:spPr>
          <a:xfrm>
            <a:off x="3259968" y="7739076"/>
            <a:ext cx="163602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≥ 5 CTC / 80 </a:t>
            </a:r>
            <a:r>
              <a:rPr lang="en-US" sz="1600" b="1" dirty="0" err="1" smtClean="0"/>
              <a:t>tdEV</a:t>
            </a:r>
            <a:endParaRPr lang="en-US" sz="1600" b="1" dirty="0" smtClean="0"/>
          </a:p>
          <a:p>
            <a:r>
              <a:rPr lang="en-US" sz="1600" b="1" dirty="0" smtClean="0"/>
              <a:t>P= 0.038</a:t>
            </a:r>
            <a:endParaRPr lang="en-US" sz="1600" b="1" dirty="0"/>
          </a:p>
        </p:txBody>
      </p:sp>
      <p:sp>
        <p:nvSpPr>
          <p:cNvPr id="5" name="Textfeld 4"/>
          <p:cNvSpPr txBox="1"/>
          <p:nvPr/>
        </p:nvSpPr>
        <p:spPr>
          <a:xfrm>
            <a:off x="8295024" y="7645754"/>
            <a:ext cx="163602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≥ 5 CTC / 80 </a:t>
            </a:r>
            <a:r>
              <a:rPr lang="en-US" sz="1600" b="1" dirty="0" err="1" smtClean="0"/>
              <a:t>tdEV</a:t>
            </a:r>
            <a:endParaRPr lang="en-US" sz="1600" b="1" dirty="0" smtClean="0"/>
          </a:p>
          <a:p>
            <a:r>
              <a:rPr lang="en-US" sz="1600" b="1" dirty="0" smtClean="0"/>
              <a:t>P= 0.010</a:t>
            </a:r>
            <a:endParaRPr lang="en-US" sz="1600" b="1" dirty="0"/>
          </a:p>
        </p:txBody>
      </p:sp>
      <p:sp>
        <p:nvSpPr>
          <p:cNvPr id="6" name="Textfeld 5"/>
          <p:cNvSpPr txBox="1"/>
          <p:nvPr/>
        </p:nvSpPr>
        <p:spPr>
          <a:xfrm>
            <a:off x="334879" y="6698147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</a:t>
            </a:r>
            <a:r>
              <a:rPr lang="en-US" b="1" dirty="0" smtClean="0"/>
              <a:t>.</a:t>
            </a:r>
            <a:endParaRPr lang="en-US" b="1" dirty="0"/>
          </a:p>
        </p:txBody>
      </p:sp>
      <p:sp>
        <p:nvSpPr>
          <p:cNvPr id="7" name="Textfeld 6"/>
          <p:cNvSpPr txBox="1"/>
          <p:nvPr/>
        </p:nvSpPr>
        <p:spPr>
          <a:xfrm>
            <a:off x="5287879" y="6698147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C.</a:t>
            </a:r>
            <a:endParaRPr lang="en-US" b="1" dirty="0"/>
          </a:p>
        </p:txBody>
      </p:sp>
      <p:pic>
        <p:nvPicPr>
          <p:cNvPr id="9" name="Grafik 8"/>
          <p:cNvPicPr>
            <a:picLocks noChangeAspect="1"/>
          </p:cNvPicPr>
          <p:nvPr/>
        </p:nvPicPr>
        <p:blipFill rotWithShape="1">
          <a:blip r:embed="rId4"/>
          <a:srcRect r="31968"/>
          <a:stretch/>
        </p:blipFill>
        <p:spPr>
          <a:xfrm>
            <a:off x="234420" y="1978508"/>
            <a:ext cx="5053459" cy="4376664"/>
          </a:xfrm>
          <a:prstGeom prst="rect">
            <a:avLst/>
          </a:prstGeom>
        </p:spPr>
      </p:pic>
      <p:sp>
        <p:nvSpPr>
          <p:cNvPr id="10" name="Textfeld 9"/>
          <p:cNvSpPr txBox="1"/>
          <p:nvPr/>
        </p:nvSpPr>
        <p:spPr>
          <a:xfrm>
            <a:off x="3285714" y="2559591"/>
            <a:ext cx="1636025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/>
              <a:t>≥ 5 CTC / 80 </a:t>
            </a:r>
            <a:r>
              <a:rPr lang="en-US" sz="1600" b="1" dirty="0" err="1" smtClean="0"/>
              <a:t>tdEV</a:t>
            </a:r>
            <a:endParaRPr lang="en-US" sz="1600" b="1" dirty="0" smtClean="0"/>
          </a:p>
          <a:p>
            <a:r>
              <a:rPr lang="en-US" sz="1600" b="1" dirty="0" smtClean="0"/>
              <a:t> P= 0.022</a:t>
            </a:r>
            <a:endParaRPr lang="en-US" sz="1600" b="1" dirty="0"/>
          </a:p>
        </p:txBody>
      </p:sp>
      <p:sp>
        <p:nvSpPr>
          <p:cNvPr id="11" name="Textfeld 10"/>
          <p:cNvSpPr txBox="1"/>
          <p:nvPr/>
        </p:nvSpPr>
        <p:spPr>
          <a:xfrm>
            <a:off x="436724" y="1540707"/>
            <a:ext cx="10412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308317" y="213003"/>
            <a:ext cx="2749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5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86774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5</Words>
  <Application>Microsoft Office PowerPoint</Application>
  <PresentationFormat>Benutzerdefiniert</PresentationFormat>
  <Paragraphs>50</Paragraphs>
  <Slides>5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rism 8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is Alsousli</dc:creator>
  <cp:lastModifiedBy>ITB_174242</cp:lastModifiedBy>
  <cp:revision>357</cp:revision>
  <cp:lastPrinted>2025-02-24T18:01:40Z</cp:lastPrinted>
  <dcterms:created xsi:type="dcterms:W3CDTF">2022-10-18T13:18:59Z</dcterms:created>
  <dcterms:modified xsi:type="dcterms:W3CDTF">2026-04-02T11:51:17Z</dcterms:modified>
</cp:coreProperties>
</file>